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DF4E5-3F7F-4621-9A9F-6735324B14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4693B-A707-451A-82EF-E9D980FB44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4379E-1A95-4539-8107-4992E4BFE8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6A9AD-BD1F-4AB8-87B8-96B2551CA6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6986F-425F-4A2B-82F0-63F392EE29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03F99-47F0-4F1C-B191-2D6D5C3F0F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219978-915A-438E-A639-B55C311AAC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D2544-6E08-43F7-949E-C2C440B50A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42B2A-AE21-4CE3-B9F2-43B597393E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D43C3-D8FF-4182-9108-AFCEFD3B66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CFE2B-D008-4F10-A29A-3EFF302105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1FD0F-C53E-4E3E-B58E-3D83921896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83BEEC-34FE-4C05-9E96-2E4DFED4F47D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 rot="5400000">
            <a:off x="1458360" y="4662720"/>
            <a:ext cx="8731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2: Immune cell subsets composition between the peripheral blood and bronchoalveolar compartmen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7"/>
          <p:cNvSpPr/>
          <p:nvPr/>
        </p:nvSpPr>
        <p:spPr>
          <a:xfrm flipH="1" rot="5400000">
            <a:off x="-2330640" y="4494240"/>
            <a:ext cx="8731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ata presented in median and interquartile range unless stated otherwise. Mann Whitney and Wilcoxon tests were used to calculate significance between the two study groups i.e. HIV- and HIV+, and within each compartment, respectively. ns means p value &gt; 0.05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 rot="5400000">
            <a:off x="60120" y="4218120"/>
            <a:ext cx="8564400" cy="130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1-07T12:49:32Z</dcterms:created>
  <dc:creator>Daniel Muema</dc:creator>
  <dc:description/>
  <dc:language>en-US</dc:language>
  <cp:lastModifiedBy>Maphe Mthembu</cp:lastModifiedBy>
  <dcterms:modified xsi:type="dcterms:W3CDTF">2020-03-18T14:57:54Z</dcterms:modified>
  <cp:revision>373</cp:revision>
  <dc:subject/>
  <dc:title>PowerPoint Presentation</dc:title>
</cp:coreProperties>
</file>